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2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15" userDrawn="1">
          <p15:clr>
            <a:srgbClr val="A4A3A4"/>
          </p15:clr>
        </p15:guide>
        <p15:guide id="5" orient="horz" pos="3120" userDrawn="1">
          <p15:clr>
            <a:srgbClr val="A4A3A4"/>
          </p15:clr>
        </p15:guide>
        <p15:guide id="7" pos="2160" userDrawn="1">
          <p15:clr>
            <a:srgbClr val="A4A3A4"/>
          </p15:clr>
        </p15:guide>
        <p15:guide id="8" orient="horz" pos="8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249FF"/>
    <a:srgbClr val="FFFE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2329"/>
    <p:restoredTop sz="94444"/>
  </p:normalViewPr>
  <p:slideViewPr>
    <p:cSldViewPr snapToGrid="0" snapToObjects="1">
      <p:cViewPr varScale="1">
        <p:scale>
          <a:sx n="73" d="100"/>
          <a:sy n="73" d="100"/>
        </p:scale>
        <p:origin x="360" y="200"/>
      </p:cViewPr>
      <p:guideLst>
        <p:guide orient="horz" pos="5615"/>
        <p:guide orient="horz" pos="3120"/>
        <p:guide pos="2160"/>
        <p:guide orient="horz" pos="8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BC56DB-7ED9-E547-B56C-B88B6FEC3E07}" type="datetimeFigureOut">
              <a:rPr lang="en-US" smtClean="0"/>
              <a:t>3/1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F4B0B5-EE68-F745-8FD0-E985A50751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54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434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8">
            <a:extLst>
              <a:ext uri="{FF2B5EF4-FFF2-40B4-BE49-F238E27FC236}">
                <a16:creationId xmlns:a16="http://schemas.microsoft.com/office/drawing/2014/main" id="{9B4E6A56-1914-BB44-92D2-772C6DE047E1}"/>
              </a:ext>
            </a:extLst>
          </p:cNvPr>
          <p:cNvSpPr txBox="1"/>
          <p:nvPr/>
        </p:nvSpPr>
        <p:spPr>
          <a:xfrm>
            <a:off x="3932880" y="423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Figure 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693FF62-1F42-9C45-AD36-FB33DB6BC54A}"/>
              </a:ext>
            </a:extLst>
          </p:cNvPr>
          <p:cNvSpPr txBox="1"/>
          <p:nvPr/>
        </p:nvSpPr>
        <p:spPr>
          <a:xfrm>
            <a:off x="491765" y="608750"/>
            <a:ext cx="32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8AEB2E5-DDE2-3844-A780-4EA411A694E2}"/>
              </a:ext>
            </a:extLst>
          </p:cNvPr>
          <p:cNvSpPr txBox="1"/>
          <p:nvPr/>
        </p:nvSpPr>
        <p:spPr>
          <a:xfrm>
            <a:off x="4768307" y="617431"/>
            <a:ext cx="32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sp>
        <p:nvSpPr>
          <p:cNvPr id="8" name="テキスト ボックス 8">
            <a:extLst>
              <a:ext uri="{FF2B5EF4-FFF2-40B4-BE49-F238E27FC236}">
                <a16:creationId xmlns:a16="http://schemas.microsoft.com/office/drawing/2014/main" id="{8C9CC3DA-C6E8-0A43-AED9-33ECD5C7C96E}"/>
              </a:ext>
            </a:extLst>
          </p:cNvPr>
          <p:cNvSpPr txBox="1"/>
          <p:nvPr/>
        </p:nvSpPr>
        <p:spPr>
          <a:xfrm>
            <a:off x="526857" y="3570930"/>
            <a:ext cx="5822831" cy="2302331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5 The influence of wortmannin (WM)</a:t>
            </a:r>
            <a:r>
              <a:rPr lang="en-US" sz="1400" b="1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on Abe-/</a:t>
            </a:r>
            <a:r>
              <a:rPr lang="en-US" sz="1400" b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Vac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-induced PI(3)P production in HeLa cells</a:t>
            </a:r>
          </a:p>
          <a:p>
            <a:pPr algn="just"/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HeLa cells stably expressing GFP-2×FYVE were exposed to vehicle (DMSO), 1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μ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WM, 1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μ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WM plus 2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μ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Abe, or 1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μ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WM plus 10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n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Vac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for 24 hrs.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Representative confocal live-cell imaging of HeLa cells stably expressing GFP-2×FYVE are shown. Nuclei (blue) were stained with Hoechst33342.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Scale bar: 20 </a:t>
            </a:r>
            <a:r>
              <a:rPr lang="en-US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Means ± S.E.M. of relative signal intensity of GFP-2×FYVE normalized against cells exposed to DMSO from three independent experiments (</a:t>
            </a:r>
            <a:r>
              <a:rPr lang="en-US" sz="14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N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= 3) including at least 34 cells are shown. * indicates P &lt;0.05 by the two-tailed unpaired </a:t>
            </a:r>
            <a:r>
              <a:rPr lang="en-US" sz="14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t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-test. </a:t>
            </a:r>
            <a:endParaRPr lang="ja-JP" sz="1400" kern="10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BBB5560-ACE4-5A45-8B7F-C45752320C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067" y="1123709"/>
            <a:ext cx="4324297" cy="206768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46514C3-0320-C241-AA2F-CA5EE6CC4A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32455" y="1123709"/>
            <a:ext cx="1332000" cy="2195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7998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453</TotalTime>
  <Words>152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ＭＳ 明朝</vt:lpstr>
      <vt:lpstr>ＭＳ 明朝</vt:lpstr>
      <vt:lpstr>游明朝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田中 良法</dc:creator>
  <cp:lastModifiedBy>田中 良法</cp:lastModifiedBy>
  <cp:revision>1557</cp:revision>
  <cp:lastPrinted>2022-02-10T10:10:52Z</cp:lastPrinted>
  <dcterms:created xsi:type="dcterms:W3CDTF">2020-08-12T02:53:40Z</dcterms:created>
  <dcterms:modified xsi:type="dcterms:W3CDTF">2024-03-11T14:27:50Z</dcterms:modified>
</cp:coreProperties>
</file>